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7315200" cy="96012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-192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0/06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0/06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0/06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0/06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0/06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0/06/2014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0/06/2014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0/06/2014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0/06/2014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0/06/2014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0/06/2014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09A6D-C09C-4548-B29A-6CF363A7E532}" type="datetimeFigureOut">
              <a:rPr lang="fr-FR" smtClean="0"/>
              <a:pPr/>
              <a:t>20/06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69735402"/>
              </p:ext>
            </p:extLst>
          </p:nvPr>
        </p:nvGraphicFramePr>
        <p:xfrm>
          <a:off x="357158" y="142852"/>
          <a:ext cx="7610795" cy="652533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56098"/>
                <a:gridCol w="477968"/>
                <a:gridCol w="1015459"/>
                <a:gridCol w="951342"/>
                <a:gridCol w="1162337"/>
                <a:gridCol w="1162337"/>
                <a:gridCol w="1022917"/>
                <a:gridCol w="1162337"/>
              </a:tblGrid>
              <a:tr h="63496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umber</a:t>
                      </a:r>
                      <a:endParaRPr lang="fr-FR" sz="12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Sex</a:t>
                      </a:r>
                      <a:endParaRPr lang="fr-FR" sz="12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SD</a:t>
                      </a:r>
                      <a:endParaRPr lang="fr-FR" sz="12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WASI</a:t>
                      </a:r>
                      <a:endParaRPr lang="fr-FR" sz="12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ing </a:t>
                      </a:r>
                      <a:r>
                        <a:rPr lang="fr-FR" sz="1200" dirty="0" err="1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skills</a:t>
                      </a:r>
                      <a:endParaRPr lang="fr-FR" sz="12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err="1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Syntactic</a:t>
                      </a:r>
                      <a:r>
                        <a:rPr lang="fr-FR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r>
                        <a:rPr lang="fr-FR" sz="1200" dirty="0" err="1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Semantic</a:t>
                      </a:r>
                      <a:r>
                        <a:rPr lang="fr-FR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(</a:t>
                      </a:r>
                      <a:r>
                        <a:rPr lang="fr-FR" sz="1200" dirty="0" err="1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years</a:t>
                      </a:r>
                      <a:r>
                        <a:rPr lang="fr-FR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  <a:endParaRPr lang="fr-FR" sz="12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Schooling</a:t>
                      </a:r>
                      <a:r>
                        <a:rPr lang="fr-FR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(</a:t>
                      </a:r>
                      <a:r>
                        <a:rPr lang="fr-FR" sz="12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hours</a:t>
                      </a:r>
                      <a:r>
                        <a:rPr lang="fr-FR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/</a:t>
                      </a:r>
                      <a:r>
                        <a:rPr lang="fr-FR" sz="12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week</a:t>
                      </a:r>
                      <a:r>
                        <a:rPr lang="fr-FR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  <a:endParaRPr lang="fr-FR" sz="12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Specific</a:t>
                      </a:r>
                      <a:r>
                        <a:rPr lang="fr-FR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care 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(</a:t>
                      </a:r>
                      <a:r>
                        <a:rPr lang="fr-FR" sz="12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hours</a:t>
                      </a:r>
                      <a:r>
                        <a:rPr lang="fr-FR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/</a:t>
                      </a:r>
                      <a:r>
                        <a:rPr lang="fr-FR" sz="12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week</a:t>
                      </a:r>
                      <a:r>
                        <a:rPr lang="fr-FR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  <a:endParaRPr lang="fr-FR" sz="12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1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S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5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on reader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4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2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6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on reader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4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2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3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DD-NOS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6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on </a:t>
                      </a:r>
                      <a:r>
                        <a:rPr lang="fr-FR" sz="10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&lt;1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4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4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DD-NOS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89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0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4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2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DD-NOS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6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&lt;1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6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0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DD-NOS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3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8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84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4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8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8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on reader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&lt;1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0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04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1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4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0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5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&lt;1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0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8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1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F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6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&lt;1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0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8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2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5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on </a:t>
                      </a:r>
                      <a:r>
                        <a:rPr lang="fr-FR" sz="10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&lt;1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8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3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2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on reader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&lt;1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0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8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4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16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2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5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6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&lt;1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4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6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5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on reader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&lt;1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8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7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8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3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8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3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on </a:t>
                      </a:r>
                      <a:r>
                        <a:rPr lang="fr-FR" sz="10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1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0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4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9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S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89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F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1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4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1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5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on reader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&lt;1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8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2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2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on </a:t>
                      </a:r>
                      <a:r>
                        <a:rPr lang="fr-FR" sz="10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&lt;1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8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3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S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29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2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4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8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on reader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&lt;1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8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8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S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00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2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6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DD-NOS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5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3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7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6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2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4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8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5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on </a:t>
                      </a:r>
                      <a:r>
                        <a:rPr lang="fr-FR" sz="10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&lt;1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8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9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DD-NOS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80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1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4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0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4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on reader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&lt;1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8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1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07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6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2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3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4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  <a:endParaRPr lang="fr-FR" sz="10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  <a:tr h="178496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3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5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on </a:t>
                      </a:r>
                      <a:r>
                        <a:rPr lang="fr-FR" sz="10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ader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8</a:t>
                      </a:r>
                      <a:endParaRPr lang="fr-FR" sz="10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0664" marR="30664" marT="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447889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316</Words>
  <Application>Microsoft Office PowerPoint</Application>
  <PresentationFormat>Affichage à l'écran (4:3)</PresentationFormat>
  <Paragraphs>27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ervice cra</dc:creator>
  <cp:lastModifiedBy>SERRET Sylvie</cp:lastModifiedBy>
  <cp:revision>7</cp:revision>
  <dcterms:created xsi:type="dcterms:W3CDTF">2014-02-02T06:50:25Z</dcterms:created>
  <dcterms:modified xsi:type="dcterms:W3CDTF">2014-06-20T12:02:06Z</dcterms:modified>
</cp:coreProperties>
</file>